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682"/>
    <p:restoredTop sz="94648"/>
  </p:normalViewPr>
  <p:slideViewPr>
    <p:cSldViewPr snapToGrid="0">
      <p:cViewPr>
        <p:scale>
          <a:sx n="81" d="100"/>
          <a:sy n="81" d="100"/>
        </p:scale>
        <p:origin x="3504" y="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77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91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876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673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587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30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8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526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721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409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061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223135-4516-F844-AE51-3D00252A963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D1260-2046-0640-8B31-1F27C76F3C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363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file:///C:/Users/Daisy/Library/Group%2520Containers/UBF8T346G9.ms/WebArchiveCopyPasteTempFiles/com.microsoft.Word/0000c4.png%3ffixed_size=1" TargetMode="External"/><Relationship Id="rId7" Type="http://schemas.openxmlformats.org/officeDocument/2006/relationships/image" Target="file:///C:/Users/Daisy/Library/Group%2520Containers/UBF8T346G9.ms/WebArchiveCopyPasteTempFiles/com.microsoft.Word/00006c.png%3ffixed_size=1" TargetMode="Externa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file:///C:/Users/Daisy/Library/Group%2520Containers/UBF8T346G9.ms/WebArchiveCopyPasteTempFiles/com.microsoft.Word/0000c5.png%3ffixed_size=1" TargetMode="External"/><Relationship Id="rId4" Type="http://schemas.openxmlformats.org/officeDocument/2006/relationships/image" Target="../media/image6.png"/><Relationship Id="rId9" Type="http://schemas.openxmlformats.org/officeDocument/2006/relationships/image" Target="file:///C:/Users/Daisy/Library/Group%2520Containers/UBF8T346G9.ms/WebArchiveCopyPasteTempFiles/com.microsoft.Word/00006d.png%3ffixed_size=1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4">
            <a:extLst>
              <a:ext uri="{FF2B5EF4-FFF2-40B4-BE49-F238E27FC236}">
                <a16:creationId xmlns:a16="http://schemas.microsoft.com/office/drawing/2014/main" id="{F263981C-4B5D-E14A-4E67-BF7A246D44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25478" y="476816"/>
            <a:ext cx="4267239" cy="533404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091E19E-AEDC-B56C-4DEE-769F3685BCD9}"/>
              </a:ext>
            </a:extLst>
          </p:cNvPr>
          <p:cNvSpPr txBox="1"/>
          <p:nvPr/>
        </p:nvSpPr>
        <p:spPr>
          <a:xfrm>
            <a:off x="235975" y="5943600"/>
            <a:ext cx="6341806" cy="3200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l Figure </a:t>
            </a: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1A</a:t>
            </a:r>
            <a:r>
              <a:rPr lang="en-US" sz="1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. PCA association plot of covariates and calculated PCs at baseline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1654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5">
            <a:extLst>
              <a:ext uri="{FF2B5EF4-FFF2-40B4-BE49-F238E27FC236}">
                <a16:creationId xmlns:a16="http://schemas.microsoft.com/office/drawing/2014/main" id="{E6BADD02-4EA6-89B4-45A5-4271814DF1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91182" y="599111"/>
            <a:ext cx="4161778" cy="520257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B291DB-F4D4-460A-CF0D-2E7EE855BD83}"/>
              </a:ext>
            </a:extLst>
          </p:cNvPr>
          <p:cNvSpPr txBox="1"/>
          <p:nvPr/>
        </p:nvSpPr>
        <p:spPr>
          <a:xfrm>
            <a:off x="235975" y="5943600"/>
            <a:ext cx="6341806" cy="573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l Figure </a:t>
            </a: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1B</a:t>
            </a:r>
            <a:r>
              <a:rPr lang="en-US" sz="1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. PCA association plot of covariates and calculated PCs after stress task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81460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3D5B45D4-9395-C9FB-4B74-C905E5532F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0331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7" descr="Chart, line chart&#10;&#10;Description automatically generated">
            <a:extLst>
              <a:ext uri="{FF2B5EF4-FFF2-40B4-BE49-F238E27FC236}">
                <a16:creationId xmlns:a16="http://schemas.microsoft.com/office/drawing/2014/main" id="{6BCB9FA6-9497-018E-5CA5-5815CEA7AE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r:link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176" y="323166"/>
            <a:ext cx="1841500" cy="275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4">
            <a:extLst>
              <a:ext uri="{FF2B5EF4-FFF2-40B4-BE49-F238E27FC236}">
                <a16:creationId xmlns:a16="http://schemas.microsoft.com/office/drawing/2014/main" id="{D5B73E11-5493-8B06-D2FA-BE59CA3C98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0331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7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7BB044DC-2C63-EEE5-D983-E8261C9B15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r:link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8935" y="331455"/>
            <a:ext cx="1841500" cy="2768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6">
            <a:extLst>
              <a:ext uri="{FF2B5EF4-FFF2-40B4-BE49-F238E27FC236}">
                <a16:creationId xmlns:a16="http://schemas.microsoft.com/office/drawing/2014/main" id="{9A5EF22E-BB8D-C993-4F78-52BED0A0F0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9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F46754AD-0E23-BC93-5E9D-32971C9251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r:link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9176" y="5026027"/>
            <a:ext cx="18288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8">
            <a:extLst>
              <a:ext uri="{FF2B5EF4-FFF2-40B4-BE49-F238E27FC236}">
                <a16:creationId xmlns:a16="http://schemas.microsoft.com/office/drawing/2014/main" id="{0D8B2096-8E22-D4B3-C80B-8881C15528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9685" y="4855779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31" name="Picture 10" descr="Chart&#10;&#10;Description automatically generated">
            <a:extLst>
              <a:ext uri="{FF2B5EF4-FFF2-40B4-BE49-F238E27FC236}">
                <a16:creationId xmlns:a16="http://schemas.microsoft.com/office/drawing/2014/main" id="{31516545-53F3-FCF1-C462-9D726D0B40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r:link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8935" y="4993425"/>
            <a:ext cx="1828800" cy="2743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7A83280-A2D1-4F3D-0423-56FF85BD97A7}"/>
              </a:ext>
            </a:extLst>
          </p:cNvPr>
          <p:cNvSpPr txBox="1"/>
          <p:nvPr/>
        </p:nvSpPr>
        <p:spPr>
          <a:xfrm>
            <a:off x="369176" y="3346972"/>
            <a:ext cx="366743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l Figure 2. </a:t>
            </a:r>
            <a:r>
              <a:rPr lang="en-US" sz="1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QQ plots with lambda values for baseline transcriptomic difference comparison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11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BA6A9A-9C89-4EF5-F3C6-FD1CAD8BC61E}"/>
              </a:ext>
            </a:extLst>
          </p:cNvPr>
          <p:cNvSpPr txBox="1"/>
          <p:nvPr/>
        </p:nvSpPr>
        <p:spPr>
          <a:xfrm>
            <a:off x="369176" y="8103372"/>
            <a:ext cx="404516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Supplemental Figure 3. </a:t>
            </a:r>
            <a:r>
              <a:rPr lang="en-US" sz="11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Calibri" panose="020F0502020204030204" pitchFamily="34" charset="0"/>
              </a:rPr>
              <a:t>QQ plots with lambda values for stress-induced transcriptomic difference comparison.</a:t>
            </a:r>
            <a:endParaRPr lang="en-U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4026404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61</Words>
  <Application>Microsoft Macintosh PowerPoint</Application>
  <PresentationFormat>Letter Paper (8.5x11 in)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engel, Torsten</dc:creator>
  <cp:lastModifiedBy>Klengel, Torsten</cp:lastModifiedBy>
  <cp:revision>1</cp:revision>
  <dcterms:created xsi:type="dcterms:W3CDTF">2023-08-24T18:11:13Z</dcterms:created>
  <dcterms:modified xsi:type="dcterms:W3CDTF">2023-08-24T18:20:00Z</dcterms:modified>
</cp:coreProperties>
</file>